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401" r:id="rId2"/>
    <p:sldId id="402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87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25F910-D376-4D15-9244-2FB19AEA2C68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834684-B075-46F0-8982-F1276D5952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92102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230458-DE6F-61DD-54CA-7B3B6316A9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F673BC5-4496-5036-9472-751DEE43F6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AF2063E-4741-B35E-DF44-4AF87D00A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27CBE7-E474-2C6E-6E1A-8553C3280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0FFDA43-0004-A65F-296F-557329678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9171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727A54-9EE2-5DC8-7E9D-146B29E33C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822A521-BCF1-555A-BD3D-86EE6BC9C5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5C07859-769D-2BED-37D2-B7612704B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144EF7F-14C3-8BF2-98D3-0669C0081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DE6622B-3E7A-04B0-B200-C029731B5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963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A27C792-A6AA-8995-E51D-94D335E72F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57A8A69-1A5F-F264-FC7D-0B8CDF8815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E89471-9E3F-7B1D-66D2-E0EDDA507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0C5FD37-383E-84F8-CECF-458780D47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8E2218-1652-37EC-B9FE-4125F7544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5500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745465-5A01-98A0-65A1-667B00E100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EEC8E12-6CBA-3A85-769A-D6AA59EF6E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215262-D70B-25B0-6B74-0BF636B9E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A39B0C3-4069-73F9-640A-394F0ADCF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92AA76B-3DBE-F923-DF3B-E0771BF220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5699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8151FB-FDEE-9BD3-8CCF-726843A53A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D692EAE-4AE6-9701-12E9-54C9B0CFE5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023E3F-4C5E-E8AE-EA8C-EC75065C2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704E38-DB23-EA93-9974-CB5BF23FF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24191C-FBCC-1334-424B-C85491843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0708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442E3F-E380-E98F-4EFE-195AB7875A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A3CD23D-FD93-56FB-DE5E-B83DDCEDB7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80D1FEE-0FD7-179E-0A8E-2A095B38DB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2D26BB2-89D3-FBB7-9C80-40F7A51EA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30C4B63-CBB4-7E9F-C1BA-0561CAF0D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67B75B2-0806-02B7-DBE7-6B390230A5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5803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D73A19A-753D-58DB-6E08-9F062147E0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D5F8D53-FA2C-2E2B-17A1-2F28CE8C93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7B5A348-F622-4C1C-C6D5-53A88E603B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F119FFB-D531-9FFD-EB11-083F939023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7D5C17D-7702-5446-9F99-44602CEFA9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DF46146-61DF-018B-89F4-BDE52CEB1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86FC6D7-28CA-1861-2E1F-26C508287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F546EAF-C01F-BA23-F5BD-61D3122E0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125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13F9B0-9ABB-6791-4C9F-B393D9FA4D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401572A-18A3-87A0-EF8F-71DC16483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62FD7D8-2E85-F3E3-66BE-DC03BF7E2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D5F9049-9F52-5304-83FA-E67978907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9258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012C83F-F8F7-500E-BCFA-4E64F840DB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64CD659-29B2-0259-7E91-F9AEFE914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A07F1E0-87AA-6DBE-749D-8BD2866AA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4574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477211-B815-0D33-941B-AAA9AE9B3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BCC9AA4-A297-7760-BB49-FC4BFAD7BE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AED2A90-A422-465D-1AA8-FA0218EDF4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2E50673-540F-FB78-F11B-0D6E6CBCA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5076078-116C-DCBF-714E-5D651DF58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8EFD68B-9DC7-F75D-4757-DDC91D2F2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768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570334-6329-F6AC-80FD-5236E48892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EAE9065-E242-ACAF-56EF-F1F2A15E80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50EE2EA-7043-A05F-0323-FF65093845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8DC2A04-F77D-03BF-7F51-755BD15AD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2F3E9AF-AFDA-3431-C1C9-CD50FBD51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8C3587-5647-234B-3E9B-E2AB0C9A0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766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E24178E-F54C-1FAF-B379-23163EE59C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954DE43-1265-A8D2-CDA3-B43373536E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54AFAEE-6D32-3C8E-5BA1-1715A01C72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3C18D-DB3D-4DD7-99AC-264DDDF973DC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020A96-0426-58D2-74F7-8DF8EAD04A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169191-A773-51E2-E200-2A27A56FC9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E7B5BA-A910-4BBA-812A-5177095D1B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7091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9B34BFA-1C71-9284-3027-B0DC5F6C3135}"/>
              </a:ext>
            </a:extLst>
          </p:cNvPr>
          <p:cNvSpPr txBox="1"/>
          <p:nvPr/>
        </p:nvSpPr>
        <p:spPr>
          <a:xfrm>
            <a:off x="281578" y="478971"/>
            <a:ext cx="75889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dditional file 1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　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Impact of body surface area on infusion rate at first nausea onset during </a:t>
            </a:r>
            <a:r>
              <a:rPr lang="en-US" altLang="ja-JP" sz="1200" dirty="0" err="1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zolbetuximab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administratio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4" name="図 3" descr="グラフ, 箱ひげ図">
            <a:extLst>
              <a:ext uri="{FF2B5EF4-FFF2-40B4-BE49-F238E27FC236}">
                <a16:creationId xmlns:a16="http://schemas.microsoft.com/office/drawing/2014/main" id="{D703CB10-C79A-550C-6F6D-8DA670376C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240" y="912223"/>
            <a:ext cx="5396411" cy="5396411"/>
          </a:xfrm>
          <a:prstGeom prst="rect">
            <a:avLst/>
          </a:prstGeom>
        </p:spPr>
      </p:pic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78FD3149-E059-5BF4-9370-1F16F7DA3BDD}"/>
              </a:ext>
            </a:extLst>
          </p:cNvPr>
          <p:cNvSpPr/>
          <p:nvPr/>
        </p:nvSpPr>
        <p:spPr>
          <a:xfrm>
            <a:off x="3178629" y="1480458"/>
            <a:ext cx="2029097" cy="6705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3A77EE92-1A4F-FBB6-53CB-7CD1EF3CF770}"/>
              </a:ext>
            </a:extLst>
          </p:cNvPr>
          <p:cNvSpPr/>
          <p:nvPr/>
        </p:nvSpPr>
        <p:spPr>
          <a:xfrm>
            <a:off x="4558479" y="1037681"/>
            <a:ext cx="318654" cy="4017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4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F73CD1F7-FEAE-E4E1-EB1B-649E381F1432}"/>
              </a:ext>
            </a:extLst>
          </p:cNvPr>
          <p:cNvGraphicFramePr>
            <a:graphicFrameLocks noGrp="1"/>
          </p:cNvGraphicFramePr>
          <p:nvPr/>
        </p:nvGraphicFramePr>
        <p:xfrm>
          <a:off x="2939683" y="839065"/>
          <a:ext cx="2736000" cy="9702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08000">
                  <a:extLst>
                    <a:ext uri="{9D8B030D-6E8A-4147-A177-3AD203B41FA5}">
                      <a16:colId xmlns:a16="http://schemas.microsoft.com/office/drawing/2014/main" val="4212540053"/>
                    </a:ext>
                  </a:extLst>
                </a:gridCol>
                <a:gridCol w="864000">
                  <a:extLst>
                    <a:ext uri="{9D8B030D-6E8A-4147-A177-3AD203B41FA5}">
                      <a16:colId xmlns:a16="http://schemas.microsoft.com/office/drawing/2014/main" val="2541761800"/>
                    </a:ext>
                  </a:extLst>
                </a:gridCol>
                <a:gridCol w="864000">
                  <a:extLst>
                    <a:ext uri="{9D8B030D-6E8A-4147-A177-3AD203B41FA5}">
                      <a16:colId xmlns:a16="http://schemas.microsoft.com/office/drawing/2014/main" val="13205199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</a:t>
                      </a:r>
                      <a:r>
                        <a:rPr kumimoji="1" lang="ja-JP" alt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＜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2</a:t>
                      </a:r>
                      <a:r>
                        <a:rPr kumimoji="1" lang="ja-JP" alt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㎡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 </a:t>
                      </a:r>
                      <a:r>
                        <a:rPr kumimoji="1" lang="ja-JP" alt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2㎡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363692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, mg/h</a:t>
                      </a:r>
                    </a:p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00-NA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0</a:t>
                      </a:r>
                    </a:p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40-NA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886379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4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85470783"/>
                  </a:ext>
                </a:extLst>
              </a:tr>
            </a:tbl>
          </a:graphicData>
        </a:graphic>
      </p:graphicFrame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A011F080-9C03-8D6A-A186-F152EDCC6C81}"/>
              </a:ext>
            </a:extLst>
          </p:cNvPr>
          <p:cNvSpPr/>
          <p:nvPr/>
        </p:nvSpPr>
        <p:spPr>
          <a:xfrm>
            <a:off x="2438397" y="5482735"/>
            <a:ext cx="1314784" cy="2394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67123D8C-CD4F-0682-FBB4-EDC83A4E006D}"/>
              </a:ext>
            </a:extLst>
          </p:cNvPr>
          <p:cNvSpPr/>
          <p:nvPr/>
        </p:nvSpPr>
        <p:spPr>
          <a:xfrm>
            <a:off x="513806" y="2891246"/>
            <a:ext cx="174171" cy="7576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2B82126-0FD7-A9FB-87F9-BC0CA33C99E3}"/>
              </a:ext>
            </a:extLst>
          </p:cNvPr>
          <p:cNvSpPr txBox="1"/>
          <p:nvPr/>
        </p:nvSpPr>
        <p:spPr>
          <a:xfrm>
            <a:off x="4038938" y="2252122"/>
            <a:ext cx="10246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SA</a:t>
            </a:r>
            <a:r>
              <a:rPr kumimoji="1" lang="ja-JP" alt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＜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.52</a:t>
            </a:r>
            <a:r>
              <a:rPr kumimoji="1" lang="ja-JP" alt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㎡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13B27FC-05F0-4210-7AD0-12278194642F}"/>
              </a:ext>
            </a:extLst>
          </p:cNvPr>
          <p:cNvSpPr txBox="1"/>
          <p:nvPr/>
        </p:nvSpPr>
        <p:spPr>
          <a:xfrm>
            <a:off x="3576311" y="3368557"/>
            <a:ext cx="9252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SA </a:t>
            </a:r>
            <a:r>
              <a:rPr kumimoji="1" lang="ja-JP" alt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≥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.52㎡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7EB237D-00C8-C4D1-809B-21D1DE8CB39B}"/>
              </a:ext>
            </a:extLst>
          </p:cNvPr>
          <p:cNvSpPr txBox="1"/>
          <p:nvPr/>
        </p:nvSpPr>
        <p:spPr>
          <a:xfrm>
            <a:off x="2473233" y="5429444"/>
            <a:ext cx="13147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nfusion rate (mg/h)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44AA0F2-77BF-464A-6F10-1BA976E8DEE9}"/>
              </a:ext>
            </a:extLst>
          </p:cNvPr>
          <p:cNvSpPr txBox="1"/>
          <p:nvPr/>
        </p:nvSpPr>
        <p:spPr>
          <a:xfrm rot="16200000">
            <a:off x="-220445" y="3139264"/>
            <a:ext cx="15552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robability of no nausea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35203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79D5950-9721-03FF-C0F9-9309F78B03E7}"/>
              </a:ext>
            </a:extLst>
          </p:cNvPr>
          <p:cNvSpPr txBox="1"/>
          <p:nvPr/>
        </p:nvSpPr>
        <p:spPr>
          <a:xfrm>
            <a:off x="281578" y="478971"/>
            <a:ext cx="92161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dditional file 2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Impact of body surface area on infusion rate at the first onset of moderate-or-greater nausea during </a:t>
            </a:r>
            <a:r>
              <a:rPr kumimoji="1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zolbetuximab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administratio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4" name="図 3" descr="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42B4084A-1C17-E991-17D8-D91B6B37DAE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327" t="10714" r="3605"/>
          <a:stretch>
            <a:fillRect/>
          </a:stretch>
        </p:blipFill>
        <p:spPr>
          <a:xfrm>
            <a:off x="365757" y="1437999"/>
            <a:ext cx="5000790" cy="4957354"/>
          </a:xfrm>
          <a:prstGeom prst="rect">
            <a:avLst/>
          </a:prstGeom>
        </p:spPr>
      </p:pic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D1331526-26ED-ABEE-EA42-70975646689E}"/>
              </a:ext>
            </a:extLst>
          </p:cNvPr>
          <p:cNvSpPr/>
          <p:nvPr/>
        </p:nvSpPr>
        <p:spPr>
          <a:xfrm>
            <a:off x="3187334" y="1358534"/>
            <a:ext cx="2029097" cy="6705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DE22B609-49F4-9F0D-65BE-9E3378D93981}"/>
              </a:ext>
            </a:extLst>
          </p:cNvPr>
          <p:cNvSpPr/>
          <p:nvPr/>
        </p:nvSpPr>
        <p:spPr>
          <a:xfrm>
            <a:off x="4708815" y="1032278"/>
            <a:ext cx="318654" cy="4017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4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67CAB93E-1906-54E4-C15E-9C4B4E13345D}"/>
              </a:ext>
            </a:extLst>
          </p:cNvPr>
          <p:cNvGraphicFramePr>
            <a:graphicFrameLocks noGrp="1"/>
          </p:cNvGraphicFramePr>
          <p:nvPr/>
        </p:nvGraphicFramePr>
        <p:xfrm>
          <a:off x="3090019" y="833662"/>
          <a:ext cx="2736000" cy="9702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08000">
                  <a:extLst>
                    <a:ext uri="{9D8B030D-6E8A-4147-A177-3AD203B41FA5}">
                      <a16:colId xmlns:a16="http://schemas.microsoft.com/office/drawing/2014/main" val="4212540053"/>
                    </a:ext>
                  </a:extLst>
                </a:gridCol>
                <a:gridCol w="864000">
                  <a:extLst>
                    <a:ext uri="{9D8B030D-6E8A-4147-A177-3AD203B41FA5}">
                      <a16:colId xmlns:a16="http://schemas.microsoft.com/office/drawing/2014/main" val="2541761800"/>
                    </a:ext>
                  </a:extLst>
                </a:gridCol>
                <a:gridCol w="864000">
                  <a:extLst>
                    <a:ext uri="{9D8B030D-6E8A-4147-A177-3AD203B41FA5}">
                      <a16:colId xmlns:a16="http://schemas.microsoft.com/office/drawing/2014/main" val="13205199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</a:t>
                      </a:r>
                      <a:r>
                        <a:rPr kumimoji="1" lang="ja-JP" alt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＜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2</a:t>
                      </a:r>
                      <a:r>
                        <a:rPr kumimoji="1" lang="ja-JP" alt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㎡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 </a:t>
                      </a:r>
                      <a:r>
                        <a:rPr kumimoji="1" lang="ja-JP" alt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2㎡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363692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, mg/h</a:t>
                      </a:r>
                    </a:p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00-NA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00-NA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8863794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4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85470783"/>
                  </a:ext>
                </a:extLst>
              </a:tr>
            </a:tbl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05CB36F-EC56-10EF-16A5-3E1C20CF9BC4}"/>
              </a:ext>
            </a:extLst>
          </p:cNvPr>
          <p:cNvSpPr txBox="1"/>
          <p:nvPr/>
        </p:nvSpPr>
        <p:spPr>
          <a:xfrm>
            <a:off x="4117312" y="2042353"/>
            <a:ext cx="10246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SA</a:t>
            </a:r>
            <a:r>
              <a:rPr kumimoji="1" lang="ja-JP" alt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＜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.52</a:t>
            </a:r>
            <a:r>
              <a:rPr kumimoji="1" lang="ja-JP" alt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㎡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FBA41AB-949B-5A8E-B3B5-E1B68785D4AC}"/>
              </a:ext>
            </a:extLst>
          </p:cNvPr>
          <p:cNvSpPr txBox="1"/>
          <p:nvPr/>
        </p:nvSpPr>
        <p:spPr>
          <a:xfrm>
            <a:off x="3532765" y="2646088"/>
            <a:ext cx="9252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SA </a:t>
            </a:r>
            <a:r>
              <a:rPr kumimoji="1" lang="ja-JP" alt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≥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.52㎡</a:t>
            </a: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37E34317-DCAC-2E21-827E-2A4ED4BA8E71}"/>
              </a:ext>
            </a:extLst>
          </p:cNvPr>
          <p:cNvSpPr/>
          <p:nvPr/>
        </p:nvSpPr>
        <p:spPr>
          <a:xfrm>
            <a:off x="2192931" y="5538826"/>
            <a:ext cx="1924381" cy="2394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1AC9C81-0967-432C-CB3E-7CA845179C2A}"/>
              </a:ext>
            </a:extLst>
          </p:cNvPr>
          <p:cNvSpPr txBox="1"/>
          <p:nvPr/>
        </p:nvSpPr>
        <p:spPr>
          <a:xfrm>
            <a:off x="2441336" y="5506381"/>
            <a:ext cx="13147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nfusion rate (mg/h)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E1462A80-8885-A3F0-002E-B9A7C4B28A1B}"/>
              </a:ext>
            </a:extLst>
          </p:cNvPr>
          <p:cNvSpPr/>
          <p:nvPr/>
        </p:nvSpPr>
        <p:spPr>
          <a:xfrm>
            <a:off x="418007" y="2882537"/>
            <a:ext cx="174171" cy="7576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BBDDC73-47A3-509D-1356-CE2CFD4CA14F}"/>
              </a:ext>
            </a:extLst>
          </p:cNvPr>
          <p:cNvSpPr txBox="1"/>
          <p:nvPr/>
        </p:nvSpPr>
        <p:spPr>
          <a:xfrm rot="16200000">
            <a:off x="-953962" y="3216425"/>
            <a:ext cx="26916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BIZ UDゴシック" panose="020B0400000000000000" pitchFamily="49" charset="-128"/>
                <a:cs typeface="Times New Roman" panose="02020603050405020304" pitchFamily="18" charset="0"/>
              </a:rPr>
              <a:t>Probability of no moderate-or-greater nausea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BIZ UDゴシック" panose="020B0400000000000000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41288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</TotalTime>
  <Words>136</Words>
  <Application>Microsoft Office PowerPoint</Application>
  <PresentationFormat>ワイド画面</PresentationFormat>
  <Paragraphs>3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洋介 安藤</dc:creator>
  <cp:lastModifiedBy>洋介 安藤</cp:lastModifiedBy>
  <cp:revision>6</cp:revision>
  <dcterms:created xsi:type="dcterms:W3CDTF">2025-12-12T04:01:36Z</dcterms:created>
  <dcterms:modified xsi:type="dcterms:W3CDTF">2026-03-18T02:04:20Z</dcterms:modified>
</cp:coreProperties>
</file>